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0287000" cy="6858000" type="35mm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 varScale="1">
        <p:scale>
          <a:sx n="67" d="100"/>
          <a:sy n="67" d="100"/>
        </p:scale>
        <p:origin x="-1368" y="-96"/>
      </p:cViewPr>
      <p:guideLst>
        <p:guide orient="horz" pos="2160"/>
        <p:guide pos="324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771525" y="2130426"/>
            <a:ext cx="874395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43050" y="3886200"/>
            <a:ext cx="72009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0882C-7492-544A-9524-A808BCBC515B}" type="datetimeFigureOut">
              <a:rPr kumimoji="1" lang="ja-JP" altLang="en-US" smtClean="0"/>
              <a:t>2016/06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7EF686-59CA-C84E-85F5-1FD7D6DC18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09743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0882C-7492-544A-9524-A808BCBC515B}" type="datetimeFigureOut">
              <a:rPr kumimoji="1" lang="ja-JP" altLang="en-US" smtClean="0"/>
              <a:t>2016/06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7EF686-59CA-C84E-85F5-1FD7D6DC18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77767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390335" y="274639"/>
            <a:ext cx="2603897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578644" y="274639"/>
            <a:ext cx="7640241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0882C-7492-544A-9524-A808BCBC515B}" type="datetimeFigureOut">
              <a:rPr kumimoji="1" lang="ja-JP" altLang="en-US" smtClean="0"/>
              <a:t>2016/06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7EF686-59CA-C84E-85F5-1FD7D6DC18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66220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0882C-7492-544A-9524-A808BCBC515B}" type="datetimeFigureOut">
              <a:rPr kumimoji="1" lang="ja-JP" altLang="en-US" smtClean="0"/>
              <a:t>2016/06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7EF686-59CA-C84E-85F5-1FD7D6DC18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89591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12602" y="4406901"/>
            <a:ext cx="874395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12602" y="2906713"/>
            <a:ext cx="874395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0882C-7492-544A-9524-A808BCBC515B}" type="datetimeFigureOut">
              <a:rPr kumimoji="1" lang="ja-JP" altLang="en-US" smtClean="0"/>
              <a:t>2016/06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7EF686-59CA-C84E-85F5-1FD7D6DC18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56238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578644" y="1600201"/>
            <a:ext cx="5122069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872162" y="1600201"/>
            <a:ext cx="5122069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0882C-7492-544A-9524-A808BCBC515B}" type="datetimeFigureOut">
              <a:rPr kumimoji="1" lang="ja-JP" altLang="en-US" smtClean="0"/>
              <a:t>2016/06/1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7EF686-59CA-C84E-85F5-1FD7D6DC18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18936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14350" y="274638"/>
            <a:ext cx="9258300" cy="1143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14350" y="1535113"/>
            <a:ext cx="4545212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14350" y="2174875"/>
            <a:ext cx="4545212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5225654" y="1535113"/>
            <a:ext cx="454699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5225654" y="2174875"/>
            <a:ext cx="454699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0882C-7492-544A-9524-A808BCBC515B}" type="datetimeFigureOut">
              <a:rPr kumimoji="1" lang="ja-JP" altLang="en-US" smtClean="0"/>
              <a:t>2016/06/12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7EF686-59CA-C84E-85F5-1FD7D6DC18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19470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0882C-7492-544A-9524-A808BCBC515B}" type="datetimeFigureOut">
              <a:rPr kumimoji="1" lang="ja-JP" altLang="en-US" smtClean="0"/>
              <a:t>2016/06/1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7EF686-59CA-C84E-85F5-1FD7D6DC18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71006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0882C-7492-544A-9524-A808BCBC515B}" type="datetimeFigureOut">
              <a:rPr kumimoji="1" lang="ja-JP" altLang="en-US" smtClean="0"/>
              <a:t>2016/06/12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7EF686-59CA-C84E-85F5-1FD7D6DC18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42607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14351" y="273050"/>
            <a:ext cx="3384352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4021931" y="273051"/>
            <a:ext cx="575071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514351" y="1435101"/>
            <a:ext cx="3384352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0882C-7492-544A-9524-A808BCBC515B}" type="datetimeFigureOut">
              <a:rPr kumimoji="1" lang="ja-JP" altLang="en-US" smtClean="0"/>
              <a:t>2016/06/1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7EF686-59CA-C84E-85F5-1FD7D6DC18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90970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016324" y="4800600"/>
            <a:ext cx="6172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2016324" y="612775"/>
            <a:ext cx="6172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2016324" y="5367338"/>
            <a:ext cx="6172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0882C-7492-544A-9524-A808BCBC515B}" type="datetimeFigureOut">
              <a:rPr kumimoji="1" lang="ja-JP" altLang="en-US" smtClean="0"/>
              <a:t>2016/06/1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7EF686-59CA-C84E-85F5-1FD7D6DC18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71354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514350" y="274638"/>
            <a:ext cx="92583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14350" y="1600201"/>
            <a:ext cx="92583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514350" y="6356351"/>
            <a:ext cx="24003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10882C-7492-544A-9524-A808BCBC515B}" type="datetimeFigureOut">
              <a:rPr kumimoji="1" lang="ja-JP" altLang="en-US" smtClean="0"/>
              <a:t>2016/06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514725" y="6356351"/>
            <a:ext cx="32575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7372350" y="6356351"/>
            <a:ext cx="24003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7EF686-59CA-C84E-85F5-1FD7D6DC18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80007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49186975"/>
              </p:ext>
            </p:extLst>
          </p:nvPr>
        </p:nvGraphicFramePr>
        <p:xfrm>
          <a:off x="192149" y="754183"/>
          <a:ext cx="9910055" cy="5122743"/>
        </p:xfrm>
        <a:graphic>
          <a:graphicData uri="http://schemas.openxmlformats.org/drawingml/2006/table">
            <a:tbl>
              <a:tblPr/>
              <a:tblGrid>
                <a:gridCol w="1684245"/>
                <a:gridCol w="1459418"/>
                <a:gridCol w="1345697"/>
                <a:gridCol w="1326743"/>
                <a:gridCol w="1307790"/>
                <a:gridCol w="1345697"/>
                <a:gridCol w="1440465"/>
              </a:tblGrid>
              <a:tr h="345145">
                <a:tc>
                  <a:txBody>
                    <a:bodyPr/>
                    <a:lstStyle/>
                    <a:p>
                      <a:pPr algn="l" fontAlgn="b"/>
                      <a:endParaRPr lang="ja-JP" alt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DILI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PBC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AHB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CHC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NASH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VH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514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Age (yr)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45.7 ± 15.9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59.7 ± 8.4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40.0 ± 17.9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65.5 ± 19.5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54.5 ± 11.2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22.8 ± 2.7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676682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Gender</a:t>
                      </a:r>
                      <a:r>
                        <a:rPr lang="ja-JP" alt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（</a:t>
                      </a:r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male/female</a:t>
                      </a:r>
                      <a:r>
                        <a:rPr lang="ja-JP" alt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）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6:13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4:16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6:2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4:4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2:8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2:3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676682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ALT (U/l</a:t>
                      </a:r>
                      <a:r>
                        <a:rPr lang="en-US" sz="2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)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1117.7 ± 1070.9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53.8 ± </a:t>
                      </a:r>
                      <a:endParaRPr lang="en-US" altLang="ja-JP" sz="20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  <a:p>
                      <a:pPr algn="ctr" fontAlgn="ctr"/>
                      <a:r>
                        <a:rPr lang="en-US" altLang="ja-JP" sz="2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39.2</a:t>
                      </a:r>
                      <a:endParaRPr lang="en-US" altLang="ja-JP" sz="2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1523.4 ± 1016.9 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48.9 ± </a:t>
                      </a:r>
                      <a:endParaRPr lang="en-US" altLang="ja-JP" sz="20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  <a:p>
                      <a:pPr algn="ctr" fontAlgn="ctr"/>
                      <a:r>
                        <a:rPr lang="en-US" altLang="ja-JP" sz="2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25.0</a:t>
                      </a:r>
                      <a:endParaRPr lang="en-US" altLang="ja-JP" sz="2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94.5 ± </a:t>
                      </a:r>
                      <a:endParaRPr lang="en-US" altLang="ja-JP" sz="20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  <a:p>
                      <a:pPr algn="ctr" fontAlgn="ctr"/>
                      <a:r>
                        <a:rPr lang="en-US" altLang="ja-JP" sz="2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90.3</a:t>
                      </a:r>
                      <a:endParaRPr lang="en-US" altLang="ja-JP" sz="2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771.8 ± </a:t>
                      </a:r>
                      <a:endParaRPr lang="en-US" altLang="ja-JP" sz="20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  <a:p>
                      <a:pPr algn="ctr" fontAlgn="ctr"/>
                      <a:r>
                        <a:rPr lang="en-US" altLang="ja-JP" sz="2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801.8</a:t>
                      </a:r>
                      <a:endParaRPr lang="en-US" altLang="ja-JP" sz="2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676682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ALP (U/l) 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663.1 ± </a:t>
                      </a:r>
                      <a:endParaRPr lang="en-US" altLang="ja-JP" sz="20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  <a:p>
                      <a:pPr algn="ctr" fontAlgn="ctr"/>
                      <a:r>
                        <a:rPr lang="en-US" altLang="ja-JP" sz="2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266.1</a:t>
                      </a:r>
                      <a:endParaRPr lang="en-US" altLang="ja-JP" sz="2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570.9 ± 415.7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580.5 ± 175.3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268.2 ± 102.7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252.7 ± </a:t>
                      </a:r>
                      <a:endParaRPr lang="en-US" altLang="ja-JP" sz="20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  <a:p>
                      <a:pPr algn="ctr" fontAlgn="ctr"/>
                      <a:r>
                        <a:rPr lang="en-US" altLang="ja-JP" sz="2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77.1</a:t>
                      </a:r>
                      <a:endParaRPr lang="en-US" altLang="ja-JP" sz="2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601.2 ± </a:t>
                      </a:r>
                      <a:endParaRPr lang="en-US" altLang="ja-JP" sz="20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  <a:p>
                      <a:pPr algn="ctr" fontAlgn="ctr"/>
                      <a:r>
                        <a:rPr lang="en-US" altLang="ja-JP" sz="2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149.1</a:t>
                      </a:r>
                      <a:endParaRPr lang="en-US" altLang="ja-JP" sz="2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45145">
                <a:tc>
                  <a:txBody>
                    <a:bodyPr/>
                    <a:lstStyle/>
                    <a:p>
                      <a:pPr algn="l" fontAlgn="ctr"/>
                      <a:r>
                        <a:rPr lang="de-DE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Alb  (g/dl)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3.3 ± 0.5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4.0 ± 0.4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3.7 ± 0.8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3.9 ± 0.2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4.3 ± 0.5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3.9 ± 0.4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4514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TB (mg/dl</a:t>
                      </a:r>
                      <a:r>
                        <a:rPr lang="en-US" sz="2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)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10.4 ± 8.9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0.9 ± 0.7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7.0 ± 6.8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0.9 ± 0.3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0.9 ± 0.2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1.2 ± 0.9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45145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PT</a:t>
                      </a:r>
                      <a:r>
                        <a:rPr lang="ja-JP" alt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(%)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76.3 ± 31.6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99.1 ± 16.8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79.5 ± 21.2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98.0 ± 11.8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105.9 ± 16.0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88.9 ± 13.9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45145">
                <a:tc>
                  <a:txBody>
                    <a:bodyPr/>
                    <a:lstStyle/>
                    <a:p>
                      <a:pPr algn="l" fontAlgn="ctr"/>
                      <a:r>
                        <a:rPr lang="el-GR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PLT (x10</a:t>
                      </a:r>
                      <a:r>
                        <a:rPr lang="el-GR" sz="20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4</a:t>
                      </a:r>
                      <a:r>
                        <a:rPr lang="el-GR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/μl)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20.8 ± 10.1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18.9 ± 6.8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23.2 ± 9.6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13.7 ± 1.9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19.3 ± 6.0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16.6 ± 1.6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676682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IgG</a:t>
                      </a:r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 (mg/dl</a:t>
                      </a:r>
                      <a:r>
                        <a:rPr lang="en-US" sz="2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)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  <a:cs typeface="Times New Roman"/>
                      </a:endParaRP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1340.4 ± 379.6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1828.9 ± 553.6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1891.5 ± 892.9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2370.7 ± 748.6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1633.0 ± 347.3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1458.0 ± 375.9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45145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ANA</a:t>
                      </a:r>
                      <a:r>
                        <a:rPr lang="ja-JP" alt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（</a:t>
                      </a:r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median</a:t>
                      </a:r>
                      <a:r>
                        <a:rPr lang="ja-JP" alt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）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-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160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-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-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80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cs typeface="Times New Roman"/>
                        </a:rPr>
                        <a:t>-</a:t>
                      </a:r>
                    </a:p>
                  </a:txBody>
                  <a:tcPr marL="12511" marR="12511" marT="12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5" name="テキスト ボックス 4"/>
          <p:cNvSpPr txBox="1"/>
          <p:nvPr/>
        </p:nvSpPr>
        <p:spPr>
          <a:xfrm>
            <a:off x="73079" y="5976532"/>
            <a:ext cx="9275361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i="1" dirty="0" smtClean="0">
                <a:latin typeface="Times New Roman"/>
                <a:cs typeface="Times New Roman"/>
              </a:rPr>
              <a:t>DILI</a:t>
            </a:r>
            <a:r>
              <a:rPr lang="en-US" altLang="ja-JP" sz="2000" dirty="0" smtClean="0">
                <a:latin typeface="Times New Roman"/>
                <a:cs typeface="Times New Roman"/>
              </a:rPr>
              <a:t> </a:t>
            </a:r>
            <a:r>
              <a:rPr lang="en-US" altLang="ja-JP" sz="2000" dirty="0">
                <a:latin typeface="Times New Roman"/>
                <a:cs typeface="Times New Roman"/>
              </a:rPr>
              <a:t>drug-induced liver </a:t>
            </a:r>
            <a:r>
              <a:rPr lang="en-US" altLang="ja-JP" sz="2000" dirty="0" smtClean="0">
                <a:latin typeface="Times New Roman"/>
                <a:cs typeface="Times New Roman"/>
              </a:rPr>
              <a:t>injury, </a:t>
            </a:r>
            <a:r>
              <a:rPr lang="en-US" altLang="ja-JP" sz="2000" i="1" dirty="0" smtClean="0">
                <a:latin typeface="Times New Roman"/>
                <a:cs typeface="Times New Roman"/>
              </a:rPr>
              <a:t>PBC</a:t>
            </a:r>
            <a:r>
              <a:rPr lang="en-US" altLang="ja-JP" sz="2000" dirty="0">
                <a:latin typeface="Times New Roman"/>
                <a:cs typeface="Times New Roman"/>
              </a:rPr>
              <a:t> </a:t>
            </a:r>
            <a:r>
              <a:rPr lang="en-US" altLang="ja-JP" sz="2000" dirty="0" smtClean="0">
                <a:latin typeface="Times New Roman"/>
                <a:cs typeface="Times New Roman"/>
              </a:rPr>
              <a:t>primary </a:t>
            </a:r>
            <a:r>
              <a:rPr lang="en-US" altLang="ja-JP" sz="2000" dirty="0">
                <a:latin typeface="Times New Roman"/>
                <a:cs typeface="Times New Roman"/>
              </a:rPr>
              <a:t>biliary </a:t>
            </a:r>
            <a:r>
              <a:rPr lang="en-US" altLang="ja-JP" sz="2000" dirty="0" smtClean="0">
                <a:latin typeface="Times New Roman"/>
                <a:cs typeface="Times New Roman"/>
              </a:rPr>
              <a:t>cholangitis, </a:t>
            </a:r>
            <a:r>
              <a:rPr lang="en-US" altLang="ja-JP" sz="2000" i="1" dirty="0" smtClean="0">
                <a:latin typeface="Times New Roman"/>
                <a:cs typeface="Times New Roman"/>
              </a:rPr>
              <a:t>AHB</a:t>
            </a:r>
            <a:r>
              <a:rPr lang="en-US" altLang="ja-JP" sz="2000" dirty="0" smtClean="0">
                <a:latin typeface="Times New Roman"/>
                <a:cs typeface="Times New Roman"/>
              </a:rPr>
              <a:t> </a:t>
            </a:r>
            <a:r>
              <a:rPr lang="en-US" altLang="ja-JP" sz="2000" dirty="0">
                <a:latin typeface="Times New Roman"/>
                <a:cs typeface="Times New Roman"/>
              </a:rPr>
              <a:t>acute hepatitis </a:t>
            </a:r>
            <a:r>
              <a:rPr lang="en-US" altLang="ja-JP" sz="2000" dirty="0" smtClean="0">
                <a:latin typeface="Times New Roman"/>
                <a:cs typeface="Times New Roman"/>
              </a:rPr>
              <a:t>B, </a:t>
            </a:r>
          </a:p>
          <a:p>
            <a:r>
              <a:rPr lang="en-US" altLang="ja-JP" sz="2000" i="1" dirty="0" smtClean="0">
                <a:latin typeface="Times New Roman"/>
                <a:cs typeface="Times New Roman"/>
              </a:rPr>
              <a:t>CHC</a:t>
            </a:r>
            <a:r>
              <a:rPr lang="en-US" altLang="ja-JP" sz="2000" dirty="0">
                <a:latin typeface="Times New Roman"/>
                <a:cs typeface="Times New Roman"/>
              </a:rPr>
              <a:t> </a:t>
            </a:r>
            <a:r>
              <a:rPr lang="en-US" altLang="ja-JP" sz="2000" dirty="0" smtClean="0">
                <a:latin typeface="Times New Roman"/>
                <a:cs typeface="Times New Roman"/>
              </a:rPr>
              <a:t>chronic </a:t>
            </a:r>
            <a:r>
              <a:rPr lang="en-US" altLang="ja-JP" sz="2000" dirty="0">
                <a:latin typeface="Times New Roman"/>
                <a:cs typeface="Times New Roman"/>
              </a:rPr>
              <a:t>hepatitis </a:t>
            </a:r>
            <a:r>
              <a:rPr lang="en-US" altLang="ja-JP" sz="2000" dirty="0" smtClean="0">
                <a:latin typeface="Times New Roman"/>
                <a:cs typeface="Times New Roman"/>
              </a:rPr>
              <a:t>C, </a:t>
            </a:r>
            <a:r>
              <a:rPr lang="en-US" altLang="ja-JP" sz="2000" i="1" dirty="0" smtClean="0">
                <a:latin typeface="Times New Roman"/>
                <a:cs typeface="Times New Roman"/>
              </a:rPr>
              <a:t>NASH</a:t>
            </a:r>
            <a:r>
              <a:rPr lang="en-US" altLang="ja-JP" sz="2000" dirty="0" smtClean="0">
                <a:latin typeface="Times New Roman"/>
                <a:cs typeface="Times New Roman"/>
              </a:rPr>
              <a:t> </a:t>
            </a:r>
            <a:r>
              <a:rPr lang="en-US" altLang="ja-JP" sz="2000" dirty="0">
                <a:latin typeface="Times New Roman"/>
                <a:cs typeface="Times New Roman"/>
              </a:rPr>
              <a:t>nonalcoholic </a:t>
            </a:r>
            <a:r>
              <a:rPr lang="en-US" altLang="ja-JP" sz="2000" dirty="0" err="1" smtClean="0">
                <a:latin typeface="Times New Roman"/>
                <a:cs typeface="Times New Roman"/>
              </a:rPr>
              <a:t>steatohepatitis</a:t>
            </a:r>
            <a:r>
              <a:rPr lang="en-US" altLang="ja-JP" sz="2000" dirty="0" smtClean="0">
                <a:latin typeface="Times New Roman"/>
                <a:cs typeface="Times New Roman"/>
              </a:rPr>
              <a:t>, </a:t>
            </a:r>
            <a:r>
              <a:rPr lang="en-US" altLang="ja-JP" sz="2000" i="1" dirty="0" smtClean="0">
                <a:latin typeface="Times New Roman"/>
                <a:cs typeface="Times New Roman"/>
              </a:rPr>
              <a:t>VH</a:t>
            </a:r>
            <a:r>
              <a:rPr lang="en-US" altLang="ja-JP" sz="2000" dirty="0" smtClean="0">
                <a:latin typeface="Times New Roman"/>
                <a:cs typeface="Times New Roman"/>
              </a:rPr>
              <a:t> </a:t>
            </a:r>
            <a:r>
              <a:rPr lang="en-US" altLang="ja-JP" sz="2000" dirty="0">
                <a:latin typeface="Times New Roman"/>
                <a:cs typeface="Times New Roman"/>
              </a:rPr>
              <a:t>viral </a:t>
            </a:r>
            <a:r>
              <a:rPr lang="en-US" altLang="ja-JP" sz="2000" dirty="0" smtClean="0">
                <a:latin typeface="Times New Roman"/>
                <a:cs typeface="Times New Roman"/>
              </a:rPr>
              <a:t>hepatitis </a:t>
            </a:r>
            <a:endParaRPr kumimoji="1" lang="ja-JP" altLang="en-US" sz="2000" dirty="0">
              <a:latin typeface="Times New Roman"/>
              <a:cs typeface="Times New Roman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177060" y="132703"/>
            <a:ext cx="98799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400" dirty="0" smtClean="0">
                <a:latin typeface="Times New Roman"/>
                <a:cs typeface="Times New Roman"/>
              </a:rPr>
              <a:t>Additional file 1: Table </a:t>
            </a:r>
            <a:r>
              <a:rPr lang="en-US" altLang="ja-JP" sz="2400" dirty="0" smtClean="0">
                <a:latin typeface="Times New Roman"/>
                <a:cs typeface="Times New Roman"/>
              </a:rPr>
              <a:t>S1</a:t>
            </a:r>
            <a:r>
              <a:rPr lang="en-US" altLang="ja-JP" sz="2400" dirty="0" smtClean="0">
                <a:latin typeface="Times New Roman"/>
                <a:cs typeface="Times New Roman"/>
              </a:rPr>
              <a:t>. Characteristics of patients with other liver diseases</a:t>
            </a:r>
            <a:endParaRPr kumimoji="1" lang="ja-JP" altLang="en-US" sz="24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150992240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268</Words>
  <Application>Microsoft Macintosh PowerPoint</Application>
  <PresentationFormat>35 mm スライド</PresentationFormat>
  <Paragraphs>86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阿部 和道</dc:creator>
  <cp:lastModifiedBy>阿部 和道</cp:lastModifiedBy>
  <cp:revision>6</cp:revision>
  <dcterms:created xsi:type="dcterms:W3CDTF">2016-06-12T01:25:22Z</dcterms:created>
  <dcterms:modified xsi:type="dcterms:W3CDTF">2016-06-12T01:52:00Z</dcterms:modified>
</cp:coreProperties>
</file>